
<file path=[Content_Types].xml><?xml version="1.0" encoding="utf-8"?>
<Types xmlns="http://schemas.openxmlformats.org/package/2006/content-types">
  <Default Extension="fntdata" ContentType="application/x-fontdata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48" r:id="rId1"/>
  </p:sldMasterIdLst>
  <p:notesMasterIdLst>
    <p:notesMasterId r:id="rId3"/>
  </p:notesMasterIdLst>
  <p:sldIdLst>
    <p:sldId id="280" r:id="rId2"/>
  </p:sldIdLst>
  <p:sldSz cx="7767638" cy="10058400"/>
  <p:notesSz cx="6858000" cy="9144000"/>
  <p:embeddedFontLst>
    <p:embeddedFont>
      <p:font typeface="Aptos Narrow" panose="020B0004020202020204" pitchFamily="34" charset="0"/>
      <p:regular r:id="rId4"/>
      <p:bold r:id="rId5"/>
      <p:italic r:id="rId6"/>
      <p:boldItalic r:id="rId7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pos="216">
          <p15:clr>
            <a:srgbClr val="747775"/>
          </p15:clr>
        </p15:guide>
        <p15:guide id="2" orient="horz" pos="3168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  <p:ext uri="GoogleSlidesCustomDataVersion2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21" roundtripDataSignature="AMtx7mhhpzlOEt5NKzBor+6azMn5nsVcQw==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51412707-7436-C1E8-E4F7-8C7A3C49224A}" name="Jennifer Sollenberger (NC)" initials="JS" userId="Jennifer Sollenberger (NC)" providerId="None"/>
  <p188:author id="{95E6C042-6BC5-BE6F-D81E-E02306B43F2B}" name="Meric-Bernstam,Funda" initials="MB" userId="S::fmeric@mdanderson.org::93eb2aa4-a862-453f-ac07-7a96bbf61352" providerId="AD"/>
  <p188:author id="{EA0D05DA-0E65-F52D-82AC-A39377BF54D7}" name="Price, Rich {GHEC~SOUTH SAN FRANCISCO}" initials="RP" userId="S::richarhp@nala.roche.com::da7f3f4b-36a6-463d-a014-3e62f009f0df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Raghav,Kanwal Pratap Singh" initials="" lastIdx="15" clrIdx="0"/>
  <p:cmAuthor id="1" name="Rich Price" initials="" lastIdx="9" clrIdx="1"/>
  <p:cmAuthor id="2" name="Jessica Grindheim" initials="" lastIdx="11" clrIdx="2"/>
  <p:cmAuthor id="3" name="Meric-Bernstam,Funda" initials="" lastIdx="4" clrIdx="3"/>
  <p:cmAuthor id="4" name="Price, Rich {GHEC~SOUTH SAN FRANCISCO}" initials="" lastIdx="3" clrIdx="4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913"/>
    <p:restoredTop sz="93993"/>
  </p:normalViewPr>
  <p:slideViewPr>
    <p:cSldViewPr snapToGrid="0">
      <p:cViewPr varScale="1">
        <p:scale>
          <a:sx n="48" d="100"/>
          <a:sy n="48" d="100"/>
        </p:scale>
        <p:origin x="1920" y="52"/>
      </p:cViewPr>
      <p:guideLst>
        <p:guide pos="216"/>
        <p:guide orient="horz" pos="3168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156" d="100"/>
          <a:sy n="156" d="100"/>
        </p:scale>
        <p:origin x="4984" y="192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26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21" Type="http://customschemas.google.com/relationships/presentationmetadata" Target="metadata"/><Relationship Id="rId7" Type="http://schemas.openxmlformats.org/officeDocument/2006/relationships/font" Target="fonts/font4.fntdata"/><Relationship Id="rId25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24" Type="http://schemas.openxmlformats.org/officeDocument/2006/relationships/viewProps" Target="viewProps.xml"/><Relationship Id="rId5" Type="http://schemas.openxmlformats.org/officeDocument/2006/relationships/font" Target="fonts/font2.fntdata"/><Relationship Id="rId23" Type="http://schemas.openxmlformats.org/officeDocument/2006/relationships/presProps" Target="presProps.xml"/><Relationship Id="rId4" Type="http://schemas.openxmlformats.org/officeDocument/2006/relationships/font" Target="fonts/font1.fntdata"/><Relationship Id="rId22" Type="http://schemas.openxmlformats.org/officeDocument/2006/relationships/commentAuthors" Target="commentAuthors.xml"/><Relationship Id="rId27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2236788" y="1143000"/>
            <a:ext cx="238442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idx="12"/>
          </p:nvPr>
        </p:nvSpPr>
        <p:spPr/>
        <p:txBody>
          <a:bodyPr/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US" sz="1200" b="0" i="0" u="none" strike="noStrike" cap="none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</a:t>
            </a:fld>
            <a:endParaRPr lang="en-US"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0838087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11"/>
          <p:cNvSpPr txBox="1">
            <a:spLocks noGrp="1"/>
          </p:cNvSpPr>
          <p:nvPr>
            <p:ph type="title"/>
          </p:nvPr>
        </p:nvSpPr>
        <p:spPr>
          <a:xfrm>
            <a:off x="529980" y="2507618"/>
            <a:ext cx="6699588" cy="4184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97"/>
              <a:buFont typeface="Calibri"/>
              <a:buNone/>
              <a:defRPr sz="509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11"/>
          <p:cNvSpPr txBox="1">
            <a:spLocks noGrp="1"/>
          </p:cNvSpPr>
          <p:nvPr>
            <p:ph type="body" idx="1"/>
          </p:nvPr>
        </p:nvSpPr>
        <p:spPr>
          <a:xfrm>
            <a:off x="529980" y="6731215"/>
            <a:ext cx="6699588" cy="22002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2039"/>
              <a:buNone/>
              <a:defRPr sz="2039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rgbClr val="888888"/>
              </a:buClr>
              <a:buSzPts val="1699"/>
              <a:buNone/>
              <a:defRPr sz="1699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rgbClr val="888888"/>
              </a:buClr>
              <a:buSzPts val="1529"/>
              <a:buNone/>
              <a:defRPr sz="1529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rgbClr val="888888"/>
              </a:buClr>
              <a:buSzPts val="1359"/>
              <a:buNone/>
              <a:defRPr sz="1359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rgbClr val="888888"/>
              </a:buClr>
              <a:buSzPts val="1359"/>
              <a:buNone/>
              <a:defRPr sz="1359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rgbClr val="888888"/>
              </a:buClr>
              <a:buSzPts val="1359"/>
              <a:buNone/>
              <a:defRPr sz="1359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rgbClr val="888888"/>
              </a:buClr>
              <a:buSzPts val="1359"/>
              <a:buNone/>
              <a:defRPr sz="1359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rgbClr val="888888"/>
              </a:buClr>
              <a:buSzPts val="1359"/>
              <a:buNone/>
              <a:defRPr sz="1359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rgbClr val="888888"/>
              </a:buClr>
              <a:buSzPts val="1359"/>
              <a:buNone/>
              <a:defRPr sz="1359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11"/>
          <p:cNvSpPr txBox="1">
            <a:spLocks noGrp="1"/>
          </p:cNvSpPr>
          <p:nvPr>
            <p:ph type="dt" idx="10"/>
          </p:nvPr>
        </p:nvSpPr>
        <p:spPr>
          <a:xfrm>
            <a:off x="534025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11"/>
          <p:cNvSpPr txBox="1">
            <a:spLocks noGrp="1"/>
          </p:cNvSpPr>
          <p:nvPr>
            <p:ph type="ftr" idx="11"/>
          </p:nvPr>
        </p:nvSpPr>
        <p:spPr>
          <a:xfrm>
            <a:off x="2573030" y="9322649"/>
            <a:ext cx="2621578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11"/>
          <p:cNvSpPr txBox="1">
            <a:spLocks noGrp="1"/>
          </p:cNvSpPr>
          <p:nvPr>
            <p:ph type="sldNum" idx="12"/>
          </p:nvPr>
        </p:nvSpPr>
        <p:spPr>
          <a:xfrm>
            <a:off x="5485894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12"/>
          <p:cNvSpPr txBox="1">
            <a:spLocks noGrp="1"/>
          </p:cNvSpPr>
          <p:nvPr>
            <p:ph type="title"/>
          </p:nvPr>
        </p:nvSpPr>
        <p:spPr>
          <a:xfrm>
            <a:off x="534025" y="535519"/>
            <a:ext cx="6699588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2"/>
          <p:cNvSpPr txBox="1">
            <a:spLocks noGrp="1"/>
          </p:cNvSpPr>
          <p:nvPr>
            <p:ph type="body" idx="1"/>
          </p:nvPr>
        </p:nvSpPr>
        <p:spPr>
          <a:xfrm>
            <a:off x="534025" y="2677584"/>
            <a:ext cx="3301246" cy="63819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12"/>
          <p:cNvSpPr txBox="1">
            <a:spLocks noGrp="1"/>
          </p:cNvSpPr>
          <p:nvPr>
            <p:ph type="body" idx="2"/>
          </p:nvPr>
        </p:nvSpPr>
        <p:spPr>
          <a:xfrm>
            <a:off x="3932367" y="2677584"/>
            <a:ext cx="3301246" cy="63819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12"/>
          <p:cNvSpPr txBox="1">
            <a:spLocks noGrp="1"/>
          </p:cNvSpPr>
          <p:nvPr>
            <p:ph type="dt" idx="10"/>
          </p:nvPr>
        </p:nvSpPr>
        <p:spPr>
          <a:xfrm>
            <a:off x="534025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12"/>
          <p:cNvSpPr txBox="1">
            <a:spLocks noGrp="1"/>
          </p:cNvSpPr>
          <p:nvPr>
            <p:ph type="ftr" idx="11"/>
          </p:nvPr>
        </p:nvSpPr>
        <p:spPr>
          <a:xfrm>
            <a:off x="2573030" y="9322649"/>
            <a:ext cx="2621578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12"/>
          <p:cNvSpPr txBox="1">
            <a:spLocks noGrp="1"/>
          </p:cNvSpPr>
          <p:nvPr>
            <p:ph type="sldNum" idx="12"/>
          </p:nvPr>
        </p:nvSpPr>
        <p:spPr>
          <a:xfrm>
            <a:off x="5485894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13"/>
          <p:cNvSpPr txBox="1">
            <a:spLocks noGrp="1"/>
          </p:cNvSpPr>
          <p:nvPr>
            <p:ph type="title"/>
          </p:nvPr>
        </p:nvSpPr>
        <p:spPr>
          <a:xfrm>
            <a:off x="535037" y="535519"/>
            <a:ext cx="6699588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3"/>
          <p:cNvSpPr txBox="1">
            <a:spLocks noGrp="1"/>
          </p:cNvSpPr>
          <p:nvPr>
            <p:ph type="body" idx="1"/>
          </p:nvPr>
        </p:nvSpPr>
        <p:spPr>
          <a:xfrm>
            <a:off x="535038" y="2465706"/>
            <a:ext cx="3286074" cy="120840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2039"/>
              <a:buNone/>
              <a:defRPr sz="2039" b="1"/>
            </a:lvl1pPr>
            <a:lvl2pPr marL="914400" lvl="1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699"/>
              <a:buNone/>
              <a:defRPr sz="1699" b="1"/>
            </a:lvl2pPr>
            <a:lvl3pPr marL="1371600" lvl="2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529"/>
              <a:buNone/>
              <a:defRPr sz="1529" b="1"/>
            </a:lvl3pPr>
            <a:lvl4pPr marL="1828800" lvl="3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4pPr>
            <a:lvl5pPr marL="2286000" lvl="4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5pPr>
            <a:lvl6pPr marL="2743200" lvl="5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6pPr>
            <a:lvl7pPr marL="3200400" lvl="6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7pPr>
            <a:lvl8pPr marL="3657600" lvl="7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8pPr>
            <a:lvl9pPr marL="4114800" lvl="8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9pPr>
          </a:lstStyle>
          <a:p>
            <a:endParaRPr/>
          </a:p>
        </p:txBody>
      </p:sp>
      <p:sp>
        <p:nvSpPr>
          <p:cNvPr id="43" name="Google Shape;43;p13"/>
          <p:cNvSpPr txBox="1">
            <a:spLocks noGrp="1"/>
          </p:cNvSpPr>
          <p:nvPr>
            <p:ph type="body" idx="2"/>
          </p:nvPr>
        </p:nvSpPr>
        <p:spPr>
          <a:xfrm>
            <a:off x="535038" y="3674110"/>
            <a:ext cx="3286074" cy="54040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13"/>
          <p:cNvSpPr txBox="1">
            <a:spLocks noGrp="1"/>
          </p:cNvSpPr>
          <p:nvPr>
            <p:ph type="body" idx="3"/>
          </p:nvPr>
        </p:nvSpPr>
        <p:spPr>
          <a:xfrm>
            <a:off x="3932367" y="2465706"/>
            <a:ext cx="3302258" cy="120840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2039"/>
              <a:buNone/>
              <a:defRPr sz="2039" b="1"/>
            </a:lvl1pPr>
            <a:lvl2pPr marL="914400" lvl="1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699"/>
              <a:buNone/>
              <a:defRPr sz="1699" b="1"/>
            </a:lvl2pPr>
            <a:lvl3pPr marL="1371600" lvl="2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529"/>
              <a:buNone/>
              <a:defRPr sz="1529" b="1"/>
            </a:lvl3pPr>
            <a:lvl4pPr marL="1828800" lvl="3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4pPr>
            <a:lvl5pPr marL="2286000" lvl="4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5pPr>
            <a:lvl6pPr marL="2743200" lvl="5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6pPr>
            <a:lvl7pPr marL="3200400" lvl="6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7pPr>
            <a:lvl8pPr marL="3657600" lvl="7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8pPr>
            <a:lvl9pPr marL="4114800" lvl="8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 b="1"/>
            </a:lvl9pPr>
          </a:lstStyle>
          <a:p>
            <a:endParaRPr/>
          </a:p>
        </p:txBody>
      </p:sp>
      <p:sp>
        <p:nvSpPr>
          <p:cNvPr id="45" name="Google Shape;45;p13"/>
          <p:cNvSpPr txBox="1">
            <a:spLocks noGrp="1"/>
          </p:cNvSpPr>
          <p:nvPr>
            <p:ph type="body" idx="4"/>
          </p:nvPr>
        </p:nvSpPr>
        <p:spPr>
          <a:xfrm>
            <a:off x="3932367" y="3674110"/>
            <a:ext cx="3302258" cy="54040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13"/>
          <p:cNvSpPr txBox="1">
            <a:spLocks noGrp="1"/>
          </p:cNvSpPr>
          <p:nvPr>
            <p:ph type="dt" idx="10"/>
          </p:nvPr>
        </p:nvSpPr>
        <p:spPr>
          <a:xfrm>
            <a:off x="534025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3"/>
          <p:cNvSpPr txBox="1">
            <a:spLocks noGrp="1"/>
          </p:cNvSpPr>
          <p:nvPr>
            <p:ph type="ftr" idx="11"/>
          </p:nvPr>
        </p:nvSpPr>
        <p:spPr>
          <a:xfrm>
            <a:off x="2573030" y="9322649"/>
            <a:ext cx="2621578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3"/>
          <p:cNvSpPr txBox="1">
            <a:spLocks noGrp="1"/>
          </p:cNvSpPr>
          <p:nvPr>
            <p:ph type="sldNum" idx="12"/>
          </p:nvPr>
        </p:nvSpPr>
        <p:spPr>
          <a:xfrm>
            <a:off x="5485894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14"/>
          <p:cNvSpPr txBox="1">
            <a:spLocks noGrp="1"/>
          </p:cNvSpPr>
          <p:nvPr>
            <p:ph type="title"/>
          </p:nvPr>
        </p:nvSpPr>
        <p:spPr>
          <a:xfrm>
            <a:off x="534025" y="535519"/>
            <a:ext cx="6699588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14"/>
          <p:cNvSpPr txBox="1">
            <a:spLocks noGrp="1"/>
          </p:cNvSpPr>
          <p:nvPr>
            <p:ph type="dt" idx="10"/>
          </p:nvPr>
        </p:nvSpPr>
        <p:spPr>
          <a:xfrm>
            <a:off x="534025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4"/>
          <p:cNvSpPr txBox="1">
            <a:spLocks noGrp="1"/>
          </p:cNvSpPr>
          <p:nvPr>
            <p:ph type="ftr" idx="11"/>
          </p:nvPr>
        </p:nvSpPr>
        <p:spPr>
          <a:xfrm>
            <a:off x="2573030" y="9322649"/>
            <a:ext cx="2621578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4"/>
          <p:cNvSpPr txBox="1">
            <a:spLocks noGrp="1"/>
          </p:cNvSpPr>
          <p:nvPr>
            <p:ph type="sldNum" idx="12"/>
          </p:nvPr>
        </p:nvSpPr>
        <p:spPr>
          <a:xfrm>
            <a:off x="5485894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5"/>
          <p:cNvSpPr txBox="1">
            <a:spLocks noGrp="1"/>
          </p:cNvSpPr>
          <p:nvPr>
            <p:ph type="dt" idx="10"/>
          </p:nvPr>
        </p:nvSpPr>
        <p:spPr>
          <a:xfrm>
            <a:off x="534025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5"/>
          <p:cNvSpPr txBox="1">
            <a:spLocks noGrp="1"/>
          </p:cNvSpPr>
          <p:nvPr>
            <p:ph type="ftr" idx="11"/>
          </p:nvPr>
        </p:nvSpPr>
        <p:spPr>
          <a:xfrm>
            <a:off x="2573030" y="9322649"/>
            <a:ext cx="2621578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15"/>
          <p:cNvSpPr txBox="1">
            <a:spLocks noGrp="1"/>
          </p:cNvSpPr>
          <p:nvPr>
            <p:ph type="sldNum" idx="12"/>
          </p:nvPr>
        </p:nvSpPr>
        <p:spPr>
          <a:xfrm>
            <a:off x="5485894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6"/>
          <p:cNvSpPr txBox="1">
            <a:spLocks noGrp="1"/>
          </p:cNvSpPr>
          <p:nvPr>
            <p:ph type="title"/>
          </p:nvPr>
        </p:nvSpPr>
        <p:spPr>
          <a:xfrm>
            <a:off x="535037" y="670560"/>
            <a:ext cx="2505265" cy="23469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718"/>
              <a:buFont typeface="Calibri"/>
              <a:buNone/>
              <a:defRPr sz="2718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6"/>
          <p:cNvSpPr txBox="1">
            <a:spLocks noGrp="1"/>
          </p:cNvSpPr>
          <p:nvPr>
            <p:ph type="body" idx="1"/>
          </p:nvPr>
        </p:nvSpPr>
        <p:spPr>
          <a:xfrm>
            <a:off x="3302258" y="1448226"/>
            <a:ext cx="3932367" cy="71479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01193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2718"/>
              <a:buChar char="•"/>
              <a:defRPr sz="2718"/>
            </a:lvl1pPr>
            <a:lvl2pPr marL="914400" lvl="1" indent="-379666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2379"/>
              <a:buChar char="•"/>
              <a:defRPr sz="2379"/>
            </a:lvl2pPr>
            <a:lvl3pPr marL="1371600" lvl="2" indent="-358076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2039"/>
              <a:buChar char="•"/>
              <a:defRPr sz="2039"/>
            </a:lvl3pPr>
            <a:lvl4pPr marL="1828800" lvl="3" indent="-336486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699"/>
              <a:buChar char="•"/>
              <a:defRPr sz="1699"/>
            </a:lvl4pPr>
            <a:lvl5pPr marL="2286000" lvl="4" indent="-336486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699"/>
              <a:buChar char="•"/>
              <a:defRPr sz="1699"/>
            </a:lvl5pPr>
            <a:lvl6pPr marL="2743200" lvl="5" indent="-336486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699"/>
              <a:buChar char="•"/>
              <a:defRPr sz="1699"/>
            </a:lvl6pPr>
            <a:lvl7pPr marL="3200400" lvl="6" indent="-336486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699"/>
              <a:buChar char="•"/>
              <a:defRPr sz="1699"/>
            </a:lvl7pPr>
            <a:lvl8pPr marL="3657600" lvl="7" indent="-336486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699"/>
              <a:buChar char="•"/>
              <a:defRPr sz="1699"/>
            </a:lvl8pPr>
            <a:lvl9pPr marL="4114800" lvl="8" indent="-336486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699"/>
              <a:buChar char="•"/>
              <a:defRPr sz="1699"/>
            </a:lvl9pPr>
          </a:lstStyle>
          <a:p>
            <a:endParaRPr/>
          </a:p>
        </p:txBody>
      </p:sp>
      <p:sp>
        <p:nvSpPr>
          <p:cNvPr id="61" name="Google Shape;61;p16"/>
          <p:cNvSpPr txBox="1">
            <a:spLocks noGrp="1"/>
          </p:cNvSpPr>
          <p:nvPr>
            <p:ph type="body" idx="2"/>
          </p:nvPr>
        </p:nvSpPr>
        <p:spPr>
          <a:xfrm>
            <a:off x="535037" y="3017520"/>
            <a:ext cx="2505265" cy="559032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/>
            </a:lvl1pPr>
            <a:lvl2pPr marL="914400" lvl="1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189"/>
              <a:buNone/>
              <a:defRPr sz="1189"/>
            </a:lvl2pPr>
            <a:lvl3pPr marL="1371600" lvl="2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019"/>
              <a:buNone/>
              <a:defRPr sz="1018"/>
            </a:lvl3pPr>
            <a:lvl4pPr marL="1828800" lvl="3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4pPr>
            <a:lvl5pPr marL="2286000" lvl="4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5pPr>
            <a:lvl6pPr marL="2743200" lvl="5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6pPr>
            <a:lvl7pPr marL="3200400" lvl="6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7pPr>
            <a:lvl8pPr marL="3657600" lvl="7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8pPr>
            <a:lvl9pPr marL="4114800" lvl="8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9pPr>
          </a:lstStyle>
          <a:p>
            <a:endParaRPr/>
          </a:p>
        </p:txBody>
      </p:sp>
      <p:sp>
        <p:nvSpPr>
          <p:cNvPr id="62" name="Google Shape;62;p16"/>
          <p:cNvSpPr txBox="1">
            <a:spLocks noGrp="1"/>
          </p:cNvSpPr>
          <p:nvPr>
            <p:ph type="dt" idx="10"/>
          </p:nvPr>
        </p:nvSpPr>
        <p:spPr>
          <a:xfrm>
            <a:off x="534025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6"/>
          <p:cNvSpPr txBox="1">
            <a:spLocks noGrp="1"/>
          </p:cNvSpPr>
          <p:nvPr>
            <p:ph type="ftr" idx="11"/>
          </p:nvPr>
        </p:nvSpPr>
        <p:spPr>
          <a:xfrm>
            <a:off x="2573030" y="9322649"/>
            <a:ext cx="2621578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6"/>
          <p:cNvSpPr txBox="1">
            <a:spLocks noGrp="1"/>
          </p:cNvSpPr>
          <p:nvPr>
            <p:ph type="sldNum" idx="12"/>
          </p:nvPr>
        </p:nvSpPr>
        <p:spPr>
          <a:xfrm>
            <a:off x="5485894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7"/>
          <p:cNvSpPr txBox="1">
            <a:spLocks noGrp="1"/>
          </p:cNvSpPr>
          <p:nvPr>
            <p:ph type="title"/>
          </p:nvPr>
        </p:nvSpPr>
        <p:spPr>
          <a:xfrm>
            <a:off x="535037" y="670560"/>
            <a:ext cx="2505265" cy="23469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718"/>
              <a:buFont typeface="Calibri"/>
              <a:buNone/>
              <a:defRPr sz="2718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7"/>
          <p:cNvSpPr>
            <a:spLocks noGrp="1"/>
          </p:cNvSpPr>
          <p:nvPr>
            <p:ph type="pic" idx="2"/>
          </p:nvPr>
        </p:nvSpPr>
        <p:spPr>
          <a:xfrm>
            <a:off x="3302258" y="1448226"/>
            <a:ext cx="3932367" cy="7147983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17"/>
          <p:cNvSpPr txBox="1">
            <a:spLocks noGrp="1"/>
          </p:cNvSpPr>
          <p:nvPr>
            <p:ph type="body" idx="1"/>
          </p:nvPr>
        </p:nvSpPr>
        <p:spPr>
          <a:xfrm>
            <a:off x="535037" y="3017520"/>
            <a:ext cx="2505265" cy="559032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1359"/>
              <a:buNone/>
              <a:defRPr sz="1359"/>
            </a:lvl1pPr>
            <a:lvl2pPr marL="914400" lvl="1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189"/>
              <a:buNone/>
              <a:defRPr sz="1189"/>
            </a:lvl2pPr>
            <a:lvl3pPr marL="1371600" lvl="2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019"/>
              <a:buNone/>
              <a:defRPr sz="1018"/>
            </a:lvl3pPr>
            <a:lvl4pPr marL="1828800" lvl="3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4pPr>
            <a:lvl5pPr marL="2286000" lvl="4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5pPr>
            <a:lvl6pPr marL="2743200" lvl="5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6pPr>
            <a:lvl7pPr marL="3200400" lvl="6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7pPr>
            <a:lvl8pPr marL="3657600" lvl="7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8pPr>
            <a:lvl9pPr marL="4114800" lvl="8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49"/>
              <a:buNone/>
              <a:defRPr sz="849"/>
            </a:lvl9pPr>
          </a:lstStyle>
          <a:p>
            <a:endParaRPr/>
          </a:p>
        </p:txBody>
      </p:sp>
      <p:sp>
        <p:nvSpPr>
          <p:cNvPr id="69" name="Google Shape;69;p17"/>
          <p:cNvSpPr txBox="1">
            <a:spLocks noGrp="1"/>
          </p:cNvSpPr>
          <p:nvPr>
            <p:ph type="dt" idx="10"/>
          </p:nvPr>
        </p:nvSpPr>
        <p:spPr>
          <a:xfrm>
            <a:off x="534025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7"/>
          <p:cNvSpPr txBox="1">
            <a:spLocks noGrp="1"/>
          </p:cNvSpPr>
          <p:nvPr>
            <p:ph type="ftr" idx="11"/>
          </p:nvPr>
        </p:nvSpPr>
        <p:spPr>
          <a:xfrm>
            <a:off x="2573030" y="9322649"/>
            <a:ext cx="2621578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7"/>
          <p:cNvSpPr txBox="1">
            <a:spLocks noGrp="1"/>
          </p:cNvSpPr>
          <p:nvPr>
            <p:ph type="sldNum" idx="12"/>
          </p:nvPr>
        </p:nvSpPr>
        <p:spPr>
          <a:xfrm>
            <a:off x="5485894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8"/>
          <p:cNvSpPr txBox="1">
            <a:spLocks noGrp="1"/>
          </p:cNvSpPr>
          <p:nvPr>
            <p:ph type="title"/>
          </p:nvPr>
        </p:nvSpPr>
        <p:spPr>
          <a:xfrm>
            <a:off x="534025" y="535519"/>
            <a:ext cx="6699588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8"/>
          <p:cNvSpPr txBox="1">
            <a:spLocks noGrp="1"/>
          </p:cNvSpPr>
          <p:nvPr>
            <p:ph type="body" idx="1"/>
          </p:nvPr>
        </p:nvSpPr>
        <p:spPr>
          <a:xfrm rot="5400000">
            <a:off x="692838" y="2518771"/>
            <a:ext cx="6381962" cy="6699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8"/>
          <p:cNvSpPr txBox="1">
            <a:spLocks noGrp="1"/>
          </p:cNvSpPr>
          <p:nvPr>
            <p:ph type="dt" idx="10"/>
          </p:nvPr>
        </p:nvSpPr>
        <p:spPr>
          <a:xfrm>
            <a:off x="534025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8"/>
          <p:cNvSpPr txBox="1">
            <a:spLocks noGrp="1"/>
          </p:cNvSpPr>
          <p:nvPr>
            <p:ph type="ftr" idx="11"/>
          </p:nvPr>
        </p:nvSpPr>
        <p:spPr>
          <a:xfrm>
            <a:off x="2573030" y="9322649"/>
            <a:ext cx="2621578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8"/>
          <p:cNvSpPr txBox="1">
            <a:spLocks noGrp="1"/>
          </p:cNvSpPr>
          <p:nvPr>
            <p:ph type="sldNum" idx="12"/>
          </p:nvPr>
        </p:nvSpPr>
        <p:spPr>
          <a:xfrm>
            <a:off x="5485894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9"/>
          <p:cNvSpPr txBox="1">
            <a:spLocks noGrp="1"/>
          </p:cNvSpPr>
          <p:nvPr>
            <p:ph type="title"/>
          </p:nvPr>
        </p:nvSpPr>
        <p:spPr>
          <a:xfrm rot="5400000">
            <a:off x="2134150" y="3960083"/>
            <a:ext cx="8524029" cy="167489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9"/>
          <p:cNvSpPr txBox="1">
            <a:spLocks noGrp="1"/>
          </p:cNvSpPr>
          <p:nvPr>
            <p:ph type="body" idx="1"/>
          </p:nvPr>
        </p:nvSpPr>
        <p:spPr>
          <a:xfrm rot="5400000">
            <a:off x="-1264191" y="2333734"/>
            <a:ext cx="8524029" cy="49275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9"/>
          <p:cNvSpPr txBox="1">
            <a:spLocks noGrp="1"/>
          </p:cNvSpPr>
          <p:nvPr>
            <p:ph type="dt" idx="10"/>
          </p:nvPr>
        </p:nvSpPr>
        <p:spPr>
          <a:xfrm>
            <a:off x="534025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9"/>
          <p:cNvSpPr txBox="1">
            <a:spLocks noGrp="1"/>
          </p:cNvSpPr>
          <p:nvPr>
            <p:ph type="ftr" idx="11"/>
          </p:nvPr>
        </p:nvSpPr>
        <p:spPr>
          <a:xfrm>
            <a:off x="2573030" y="9322649"/>
            <a:ext cx="2621578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9"/>
          <p:cNvSpPr txBox="1">
            <a:spLocks noGrp="1"/>
          </p:cNvSpPr>
          <p:nvPr>
            <p:ph type="sldNum" idx="12"/>
          </p:nvPr>
        </p:nvSpPr>
        <p:spPr>
          <a:xfrm>
            <a:off x="5485894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8"/>
          <p:cNvSpPr txBox="1">
            <a:spLocks noGrp="1"/>
          </p:cNvSpPr>
          <p:nvPr>
            <p:ph type="title"/>
          </p:nvPr>
        </p:nvSpPr>
        <p:spPr>
          <a:xfrm>
            <a:off x="534025" y="535519"/>
            <a:ext cx="6699588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738"/>
              <a:buFont typeface="Calibri"/>
              <a:buNone/>
              <a:defRPr sz="3738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8"/>
          <p:cNvSpPr txBox="1">
            <a:spLocks noGrp="1"/>
          </p:cNvSpPr>
          <p:nvPr>
            <p:ph type="body" idx="1"/>
          </p:nvPr>
        </p:nvSpPr>
        <p:spPr>
          <a:xfrm>
            <a:off x="534025" y="2677584"/>
            <a:ext cx="6699588" cy="63819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79666" algn="l" rtl="0">
              <a:lnSpc>
                <a:spcPct val="90000"/>
              </a:lnSpc>
              <a:spcBef>
                <a:spcPts val="849"/>
              </a:spcBef>
              <a:spcAft>
                <a:spcPts val="0"/>
              </a:spcAft>
              <a:buClr>
                <a:schemeClr val="dk1"/>
              </a:buClr>
              <a:buSzPts val="2379"/>
              <a:buFont typeface="Arial"/>
              <a:buChar char="•"/>
              <a:defRPr sz="237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58076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2039"/>
              <a:buFont typeface="Arial"/>
              <a:buChar char="•"/>
              <a:defRPr sz="203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36486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699"/>
              <a:buFont typeface="Arial"/>
              <a:buChar char="•"/>
              <a:defRPr sz="169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25691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529"/>
              <a:buFont typeface="Arial"/>
              <a:buChar char="•"/>
              <a:defRPr sz="152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25691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529"/>
              <a:buFont typeface="Arial"/>
              <a:buChar char="•"/>
              <a:defRPr sz="152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25691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529"/>
              <a:buFont typeface="Arial"/>
              <a:buChar char="•"/>
              <a:defRPr sz="152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25691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529"/>
              <a:buFont typeface="Arial"/>
              <a:buChar char="•"/>
              <a:defRPr sz="152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25691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529"/>
              <a:buFont typeface="Arial"/>
              <a:buChar char="•"/>
              <a:defRPr sz="152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25691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529"/>
              <a:buFont typeface="Arial"/>
              <a:buChar char="•"/>
              <a:defRPr sz="152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8"/>
          <p:cNvSpPr txBox="1">
            <a:spLocks noGrp="1"/>
          </p:cNvSpPr>
          <p:nvPr>
            <p:ph type="dt" idx="10"/>
          </p:nvPr>
        </p:nvSpPr>
        <p:spPr>
          <a:xfrm>
            <a:off x="534025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8"/>
          <p:cNvSpPr txBox="1">
            <a:spLocks noGrp="1"/>
          </p:cNvSpPr>
          <p:nvPr>
            <p:ph type="ftr" idx="11"/>
          </p:nvPr>
        </p:nvSpPr>
        <p:spPr>
          <a:xfrm>
            <a:off x="2573030" y="9322649"/>
            <a:ext cx="2621578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8"/>
          <p:cNvSpPr txBox="1">
            <a:spLocks noGrp="1"/>
          </p:cNvSpPr>
          <p:nvPr>
            <p:ph type="sldNum" idx="12"/>
          </p:nvPr>
        </p:nvSpPr>
        <p:spPr>
          <a:xfrm>
            <a:off x="5485894" y="9322649"/>
            <a:ext cx="1747719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18"/>
              <a:buFont typeface="Arial"/>
              <a:buNone/>
              <a:defRPr sz="1018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  <p:sldLayoutId id="2147483659" r:id="rId9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AD8BF897-5708-4D52-FA17-A176F76C95B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11950425"/>
              </p:ext>
            </p:extLst>
          </p:nvPr>
        </p:nvGraphicFramePr>
        <p:xfrm>
          <a:off x="536414" y="1400226"/>
          <a:ext cx="6955983" cy="1757200"/>
        </p:xfrm>
        <a:graphic>
          <a:graphicData uri="http://schemas.openxmlformats.org/drawingml/2006/table">
            <a:tbl>
              <a:tblPr/>
              <a:tblGrid>
                <a:gridCol w="257629">
                  <a:extLst>
                    <a:ext uri="{9D8B030D-6E8A-4147-A177-3AD203B41FA5}">
                      <a16:colId xmlns:a16="http://schemas.microsoft.com/office/drawing/2014/main" val="2991027895"/>
                    </a:ext>
                  </a:extLst>
                </a:gridCol>
                <a:gridCol w="257629">
                  <a:extLst>
                    <a:ext uri="{9D8B030D-6E8A-4147-A177-3AD203B41FA5}">
                      <a16:colId xmlns:a16="http://schemas.microsoft.com/office/drawing/2014/main" val="4093388872"/>
                    </a:ext>
                  </a:extLst>
                </a:gridCol>
                <a:gridCol w="257629">
                  <a:extLst>
                    <a:ext uri="{9D8B030D-6E8A-4147-A177-3AD203B41FA5}">
                      <a16:colId xmlns:a16="http://schemas.microsoft.com/office/drawing/2014/main" val="3065053636"/>
                    </a:ext>
                  </a:extLst>
                </a:gridCol>
                <a:gridCol w="257629">
                  <a:extLst>
                    <a:ext uri="{9D8B030D-6E8A-4147-A177-3AD203B41FA5}">
                      <a16:colId xmlns:a16="http://schemas.microsoft.com/office/drawing/2014/main" val="4187789239"/>
                    </a:ext>
                  </a:extLst>
                </a:gridCol>
                <a:gridCol w="257629">
                  <a:extLst>
                    <a:ext uri="{9D8B030D-6E8A-4147-A177-3AD203B41FA5}">
                      <a16:colId xmlns:a16="http://schemas.microsoft.com/office/drawing/2014/main" val="1548203782"/>
                    </a:ext>
                  </a:extLst>
                </a:gridCol>
                <a:gridCol w="257629">
                  <a:extLst>
                    <a:ext uri="{9D8B030D-6E8A-4147-A177-3AD203B41FA5}">
                      <a16:colId xmlns:a16="http://schemas.microsoft.com/office/drawing/2014/main" val="2101747187"/>
                    </a:ext>
                  </a:extLst>
                </a:gridCol>
                <a:gridCol w="257629">
                  <a:extLst>
                    <a:ext uri="{9D8B030D-6E8A-4147-A177-3AD203B41FA5}">
                      <a16:colId xmlns:a16="http://schemas.microsoft.com/office/drawing/2014/main" val="1922231170"/>
                    </a:ext>
                  </a:extLst>
                </a:gridCol>
                <a:gridCol w="257629">
                  <a:extLst>
                    <a:ext uri="{9D8B030D-6E8A-4147-A177-3AD203B41FA5}">
                      <a16:colId xmlns:a16="http://schemas.microsoft.com/office/drawing/2014/main" val="1752366571"/>
                    </a:ext>
                  </a:extLst>
                </a:gridCol>
                <a:gridCol w="257629">
                  <a:extLst>
                    <a:ext uri="{9D8B030D-6E8A-4147-A177-3AD203B41FA5}">
                      <a16:colId xmlns:a16="http://schemas.microsoft.com/office/drawing/2014/main" val="2268892056"/>
                    </a:ext>
                  </a:extLst>
                </a:gridCol>
                <a:gridCol w="257629">
                  <a:extLst>
                    <a:ext uri="{9D8B030D-6E8A-4147-A177-3AD203B41FA5}">
                      <a16:colId xmlns:a16="http://schemas.microsoft.com/office/drawing/2014/main" val="1264398207"/>
                    </a:ext>
                  </a:extLst>
                </a:gridCol>
                <a:gridCol w="257629">
                  <a:extLst>
                    <a:ext uri="{9D8B030D-6E8A-4147-A177-3AD203B41FA5}">
                      <a16:colId xmlns:a16="http://schemas.microsoft.com/office/drawing/2014/main" val="3798078045"/>
                    </a:ext>
                  </a:extLst>
                </a:gridCol>
                <a:gridCol w="257629">
                  <a:extLst>
                    <a:ext uri="{9D8B030D-6E8A-4147-A177-3AD203B41FA5}">
                      <a16:colId xmlns:a16="http://schemas.microsoft.com/office/drawing/2014/main" val="1054151781"/>
                    </a:ext>
                  </a:extLst>
                </a:gridCol>
                <a:gridCol w="257629">
                  <a:extLst>
                    <a:ext uri="{9D8B030D-6E8A-4147-A177-3AD203B41FA5}">
                      <a16:colId xmlns:a16="http://schemas.microsoft.com/office/drawing/2014/main" val="3823302773"/>
                    </a:ext>
                  </a:extLst>
                </a:gridCol>
                <a:gridCol w="133804">
                  <a:extLst>
                    <a:ext uri="{9D8B030D-6E8A-4147-A177-3AD203B41FA5}">
                      <a16:colId xmlns:a16="http://schemas.microsoft.com/office/drawing/2014/main" val="3381838804"/>
                    </a:ext>
                  </a:extLst>
                </a:gridCol>
                <a:gridCol w="123825">
                  <a:extLst>
                    <a:ext uri="{9D8B030D-6E8A-4147-A177-3AD203B41FA5}">
                      <a16:colId xmlns:a16="http://schemas.microsoft.com/office/drawing/2014/main" val="2037983751"/>
                    </a:ext>
                  </a:extLst>
                </a:gridCol>
                <a:gridCol w="257629">
                  <a:extLst>
                    <a:ext uri="{9D8B030D-6E8A-4147-A177-3AD203B41FA5}">
                      <a16:colId xmlns:a16="http://schemas.microsoft.com/office/drawing/2014/main" val="636083695"/>
                    </a:ext>
                  </a:extLst>
                </a:gridCol>
                <a:gridCol w="257629">
                  <a:extLst>
                    <a:ext uri="{9D8B030D-6E8A-4147-A177-3AD203B41FA5}">
                      <a16:colId xmlns:a16="http://schemas.microsoft.com/office/drawing/2014/main" val="2786419241"/>
                    </a:ext>
                  </a:extLst>
                </a:gridCol>
                <a:gridCol w="257629">
                  <a:extLst>
                    <a:ext uri="{9D8B030D-6E8A-4147-A177-3AD203B41FA5}">
                      <a16:colId xmlns:a16="http://schemas.microsoft.com/office/drawing/2014/main" val="2785340020"/>
                    </a:ext>
                  </a:extLst>
                </a:gridCol>
                <a:gridCol w="257629">
                  <a:extLst>
                    <a:ext uri="{9D8B030D-6E8A-4147-A177-3AD203B41FA5}">
                      <a16:colId xmlns:a16="http://schemas.microsoft.com/office/drawing/2014/main" val="2151819497"/>
                    </a:ext>
                  </a:extLst>
                </a:gridCol>
                <a:gridCol w="257629">
                  <a:extLst>
                    <a:ext uri="{9D8B030D-6E8A-4147-A177-3AD203B41FA5}">
                      <a16:colId xmlns:a16="http://schemas.microsoft.com/office/drawing/2014/main" val="1805450943"/>
                    </a:ext>
                  </a:extLst>
                </a:gridCol>
                <a:gridCol w="257629">
                  <a:extLst>
                    <a:ext uri="{9D8B030D-6E8A-4147-A177-3AD203B41FA5}">
                      <a16:colId xmlns:a16="http://schemas.microsoft.com/office/drawing/2014/main" val="3001897344"/>
                    </a:ext>
                  </a:extLst>
                </a:gridCol>
                <a:gridCol w="257629">
                  <a:extLst>
                    <a:ext uri="{9D8B030D-6E8A-4147-A177-3AD203B41FA5}">
                      <a16:colId xmlns:a16="http://schemas.microsoft.com/office/drawing/2014/main" val="3797750420"/>
                    </a:ext>
                  </a:extLst>
                </a:gridCol>
                <a:gridCol w="257629">
                  <a:extLst>
                    <a:ext uri="{9D8B030D-6E8A-4147-A177-3AD203B41FA5}">
                      <a16:colId xmlns:a16="http://schemas.microsoft.com/office/drawing/2014/main" val="2307178191"/>
                    </a:ext>
                  </a:extLst>
                </a:gridCol>
                <a:gridCol w="257629">
                  <a:extLst>
                    <a:ext uri="{9D8B030D-6E8A-4147-A177-3AD203B41FA5}">
                      <a16:colId xmlns:a16="http://schemas.microsoft.com/office/drawing/2014/main" val="1269461354"/>
                    </a:ext>
                  </a:extLst>
                </a:gridCol>
                <a:gridCol w="257629">
                  <a:extLst>
                    <a:ext uri="{9D8B030D-6E8A-4147-A177-3AD203B41FA5}">
                      <a16:colId xmlns:a16="http://schemas.microsoft.com/office/drawing/2014/main" val="3771452999"/>
                    </a:ext>
                  </a:extLst>
                </a:gridCol>
                <a:gridCol w="257629">
                  <a:extLst>
                    <a:ext uri="{9D8B030D-6E8A-4147-A177-3AD203B41FA5}">
                      <a16:colId xmlns:a16="http://schemas.microsoft.com/office/drawing/2014/main" val="2163410314"/>
                    </a:ext>
                  </a:extLst>
                </a:gridCol>
                <a:gridCol w="257629">
                  <a:extLst>
                    <a:ext uri="{9D8B030D-6E8A-4147-A177-3AD203B41FA5}">
                      <a16:colId xmlns:a16="http://schemas.microsoft.com/office/drawing/2014/main" val="3265633757"/>
                    </a:ext>
                  </a:extLst>
                </a:gridCol>
                <a:gridCol w="257629">
                  <a:extLst>
                    <a:ext uri="{9D8B030D-6E8A-4147-A177-3AD203B41FA5}">
                      <a16:colId xmlns:a16="http://schemas.microsoft.com/office/drawing/2014/main" val="1160681453"/>
                    </a:ext>
                  </a:extLst>
                </a:gridCol>
              </a:tblGrid>
              <a:tr h="76912"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KRAS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BRCA2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APC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MET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ATM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DK12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ERBB2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FGFR1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AR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NRAS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PTEN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ESR1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TSC1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EGFR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BRCA1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MAP2K1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IDH1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PIK3CA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MTOR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FGFR2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DK6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DK4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BRAF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FGFR3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HOA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KIT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patient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06766749"/>
                  </a:ext>
                </a:extLst>
              </a:tr>
              <a:tr h="76912"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1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27987496"/>
                  </a:ext>
                </a:extLst>
              </a:tr>
              <a:tr h="76912"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M1043I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3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96777793"/>
                  </a:ext>
                </a:extLst>
              </a:tr>
              <a:tr h="76912"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anp 2.55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K980T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K367M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4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05169463"/>
                  </a:ext>
                </a:extLst>
              </a:tr>
              <a:tr h="76912"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amp 2.3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33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56744884"/>
                  </a:ext>
                </a:extLst>
              </a:tr>
              <a:tr h="76912"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Fusion TACC3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5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86740226"/>
                  </a:ext>
                </a:extLst>
              </a:tr>
              <a:tr h="76912"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D1267fs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H279D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8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22848422"/>
                  </a:ext>
                </a:extLst>
              </a:tr>
              <a:tr h="76912"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anp 2.37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D891H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amp 2.33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foc 2.82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anp 2.65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anp 2.85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7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11961351"/>
                  </a:ext>
                </a:extLst>
              </a:tr>
              <a:tr h="76912"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Q61H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L2452fs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L926P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A328T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S868N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37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47527704"/>
                  </a:ext>
                </a:extLst>
              </a:tr>
              <a:tr h="76912"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L5I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8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38040551"/>
                  </a:ext>
                </a:extLst>
              </a:tr>
              <a:tr h="76912"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V505L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F425V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E1101K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E561fs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7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11385905"/>
                  </a:ext>
                </a:extLst>
              </a:tr>
              <a:tr h="76912"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anp 2.34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</a:t>
                      </a:r>
                      <a:r>
                        <a:rPr lang="en-US" sz="3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foc</a:t>
                      </a:r>
                      <a:r>
                        <a:rPr lang="en-US" sz="3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 3.38*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anp 2.5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foc 2.44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39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06186128"/>
                  </a:ext>
                </a:extLst>
              </a:tr>
              <a:tr h="142048"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Q61H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L2056P|D227G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K139T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V356G|N530T|A775_G776insYVMA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L635R|E2D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K170N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K57T|L54P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K126N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4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98773363"/>
                  </a:ext>
                </a:extLst>
              </a:tr>
              <a:tr h="76912"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G12D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N2644S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Y1003F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3008H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D1352fs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3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3107043"/>
                  </a:ext>
                </a:extLst>
              </a:tr>
              <a:tr h="76912"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anp 2.3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</a:t>
                      </a:r>
                      <a:r>
                        <a:rPr lang="en-US" sz="3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anp</a:t>
                      </a:r>
                      <a:r>
                        <a:rPr lang="en-US" sz="3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 3.01*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E40Q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5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06030113"/>
                  </a:ext>
                </a:extLst>
              </a:tr>
              <a:tr h="76912"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40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69984758"/>
                  </a:ext>
                </a:extLst>
              </a:tr>
              <a:tr h="76912"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01925196"/>
                  </a:ext>
                </a:extLst>
              </a:tr>
              <a:tr h="76912"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G12D|G13D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M1890K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P1140F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8977980"/>
                  </a:ext>
                </a:extLst>
              </a:tr>
              <a:tr h="76912"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I124fs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3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29954391"/>
                  </a:ext>
                </a:extLst>
              </a:tr>
              <a:tr h="76912"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S310F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NV amp 2.25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6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41400101"/>
                  </a:ext>
                </a:extLst>
              </a:tr>
              <a:tr h="76912"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Q61H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G12C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N94fs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9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66487146"/>
                  </a:ext>
                </a:extLst>
              </a:tr>
              <a:tr h="76912"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S2143P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G853D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487W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A417T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3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3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36</a:t>
                      </a:r>
                    </a:p>
                  </a:txBody>
                  <a:tcPr marL="2761" marR="2761" marT="2761" marB="0" anchor="b">
                    <a:lnL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>
                          <a:lumMod val="90000"/>
                        </a:schemeClr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59244855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641594EB-218B-25DD-177F-8449521F351B}"/>
              </a:ext>
            </a:extLst>
          </p:cNvPr>
          <p:cNvSpPr txBox="1"/>
          <p:nvPr/>
        </p:nvSpPr>
        <p:spPr>
          <a:xfrm>
            <a:off x="479112" y="3472604"/>
            <a:ext cx="314504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/>
              <a:t>* Should not be considered “acquired” at PD since CNV of ERBB2 was the basis for study inclusion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65734DF-BF84-11E0-A90D-05DD8F76689E}"/>
              </a:ext>
            </a:extLst>
          </p:cNvPr>
          <p:cNvSpPr txBox="1"/>
          <p:nvPr/>
        </p:nvSpPr>
        <p:spPr>
          <a:xfrm>
            <a:off x="330990" y="931159"/>
            <a:ext cx="46979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</a:t>
            </a:r>
            <a:r>
              <a:rPr lang="en-US"/>
              <a:t>Table 4:   </a:t>
            </a:r>
            <a:r>
              <a:rPr lang="en-US" dirty="0"/>
              <a:t>PD Acquired Variants</a:t>
            </a:r>
          </a:p>
        </p:txBody>
      </p:sp>
    </p:spTree>
    <p:extLst>
      <p:ext uri="{BB962C8B-B14F-4D97-AF65-F5344CB8AC3E}">
        <p14:creationId xmlns:p14="http://schemas.microsoft.com/office/powerpoint/2010/main" val="17058180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418</TotalTime>
  <Words>178</Words>
  <Application>Microsoft Office PowerPoint</Application>
  <PresentationFormat>Custom</PresentationFormat>
  <Paragraphs>10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Aptos Narrow</vt:lpstr>
      <vt:lpstr>Arial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 for Her2 ctDNA MyPathway ms</dc:title>
  <dc:creator>Price, Rich {GHEC~SOUTH SAN FRANCISCO}</dc:creator>
  <cp:lastModifiedBy>Michael Davidson</cp:lastModifiedBy>
  <cp:revision>48</cp:revision>
  <cp:lastPrinted>2024-03-19T18:17:19Z</cp:lastPrinted>
  <dcterms:created xsi:type="dcterms:W3CDTF">2023-04-27T13:05:28Z</dcterms:created>
  <dcterms:modified xsi:type="dcterms:W3CDTF">2025-04-09T15:33:56Z</dcterms:modified>
</cp:coreProperties>
</file>